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4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76" y="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60E1EC-C8EE-2E13-AB09-31AC87028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A66084-C0DF-3458-A55B-565979522D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A83157-9FF6-C09C-28E0-49F72E0B5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FED0A9-F849-9F6E-8297-4296CEEA9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DF8B5F-DE74-ED3E-BBD0-5686DD9CD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666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813F4-358D-4A86-103F-A7DDB0DB7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1CD7AE-1D87-9736-0E77-D81A9D5232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41B18-7D0F-8674-D2A9-EA9D19ABC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3C3D43-4B35-6FFE-5D12-D08CA0E6A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86EF21-AF63-344D-6CBC-26B00BBFC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880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E19743-FE5C-F896-84B0-06E0D8B7EE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8C6312-434A-20A4-A57D-E53D4C69EE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159181-B75A-9D61-FA0E-0C3D35877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A43A6-4B20-164D-C6D5-2C423FDFA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56A1EE-4A74-03D8-3A92-23D1CD2CD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504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AD6DA9-FD36-0162-8D5F-1A7511C85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21ACC5-3427-4739-25DB-98D030D12D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E36911-FA20-685E-C5F6-98027708A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493910-74B3-E65E-000C-8AA13674C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A6F82F-3210-1967-19F6-D942343C6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736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DEB3D-0B29-4BED-41C9-82DDB83BF9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6553E7-C413-0DED-FEDE-42EBD9B79E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C2EB5C-F81B-DBDA-B57C-C13E963D9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51A30E-5404-88E3-2B9E-C1E12A8E3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0AE71A-FC92-4779-278C-DED191E67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742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E5E6E-F730-BDAB-C1FB-4BDEE0A54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C50007-B0B4-A909-91D0-92167FD1D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0C3E50-995D-005E-4485-C3D72CFA35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91E9B6-E828-0FC4-84EE-F35702433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997749-E1AD-1047-7465-26A97B2C0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312E32-838B-167C-96B9-074AC4228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772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E3354-AE33-A673-7120-0667E8AC16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D48463-C4E7-F3A7-5599-8F8B2F9EF2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1B6A70-3F9A-7857-08C7-089EE60CB2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DF080B-0518-5F94-9172-95A8C28115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F710A6-34A7-A518-41B5-DE2AEED21B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A1A856-4D0B-4BEB-0B29-ED54B1B3E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BA676E-E40E-1CE7-B70D-2C0C49A1B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5BD173-B674-DF23-3765-CD3A65289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544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3A452-75EF-7805-9B16-E302B9CFA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943BF7-23D4-F84D-36F3-38F60EB0B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45D679-A495-376A-A747-DAFA9D51E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306F27-BB1C-7061-1446-69F36561E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594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ED9CF5-A3EE-D34D-EAB0-3541CFEE4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6FA19A7-8BE0-74CC-9196-BF118F7A0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B07C4F-C68D-8437-DECA-1B4F044FC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904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B86F6A-C28F-5D0C-8A6D-E17DA3622C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FE73D5-758F-83A5-1996-E9FF825993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563637-D74E-C966-F431-7FCC7DD090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37F05B-BC16-C395-ABEC-0C65EA520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F1C4A5-8E30-9BA3-6CDF-BE8CFDF67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468C8A-4E5B-6D41-9372-6DCD6A32C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52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64103-BBF8-991E-52FC-B467CF9E76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797865-0682-A90B-8FBE-1992788439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C122A6-E213-8931-999B-178F5C5ABA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CEAC68-A89E-68F6-5B07-C77F05ED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8D9C05-7F4D-123C-08B3-BA54D0EFA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CA99D0-751E-986E-586A-9B56BA727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584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899C95-3F1C-0560-C45F-4076654082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63C58E-36AB-E697-5B4F-81502A3046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CA71C3-5C3D-8869-3736-807C092E2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9C70E8-D2D7-44C2-A880-EFCFD546CCCF}" type="datetimeFigureOut">
              <a:rPr lang="en-US" smtClean="0"/>
              <a:t>4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410B71-9F90-AED1-8069-0FD77770F0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C28D6D-E12F-37AC-5ECB-3DD0E0D47B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DF0059-FD97-4DF5-AFA9-83E4635CDC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5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10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7C895FC8-E2B0-A5AA-F1A4-8AB55501A4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17" b="2815"/>
          <a:stretch/>
        </p:blipFill>
        <p:spPr>
          <a:xfrm>
            <a:off x="2744771" y="770313"/>
            <a:ext cx="5663583" cy="504859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DE474B-B391-9770-2DCC-0780034C3F88}"/>
              </a:ext>
            </a:extLst>
          </p:cNvPr>
          <p:cNvSpPr txBox="1"/>
          <p:nvPr/>
        </p:nvSpPr>
        <p:spPr>
          <a:xfrm>
            <a:off x="1828799" y="5977069"/>
            <a:ext cx="975914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errain overview. A) Expression matrix. B) PPI network. C) Gaussian formula. D) Terrain per sample. E)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σ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 effects on S1 terrain.</a:t>
            </a:r>
          </a:p>
        </p:txBody>
      </p:sp>
    </p:spTree>
    <p:extLst>
      <p:ext uri="{BB962C8B-B14F-4D97-AF65-F5344CB8AC3E}">
        <p14:creationId xmlns:p14="http://schemas.microsoft.com/office/powerpoint/2010/main" val="4068519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55F86A2-850F-B725-68AD-D655E9CA97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9059" y="681954"/>
            <a:ext cx="10135121" cy="381654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9D6A463-2084-698E-BD20-D3887D97ECD2}"/>
              </a:ext>
            </a:extLst>
          </p:cNvPr>
          <p:cNvSpPr txBox="1"/>
          <p:nvPr/>
        </p:nvSpPr>
        <p:spPr>
          <a:xfrm>
            <a:off x="1170500" y="4705491"/>
            <a:ext cx="1008418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ic heatmap of LNCaP gene expression across 0–24 h time points with hierarchical clustering. Each column represents a time-point treatment condition, and each row a gene, colored by Z-score normalized expression (red = upregulated; blue = downregulated).</a:t>
            </a:r>
          </a:p>
        </p:txBody>
      </p:sp>
    </p:spTree>
    <p:extLst>
      <p:ext uri="{BB962C8B-B14F-4D97-AF65-F5344CB8AC3E}">
        <p14:creationId xmlns:p14="http://schemas.microsoft.com/office/powerpoint/2010/main" val="3579277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82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ghapour, Ehsan (Campus)</dc:creator>
  <cp:lastModifiedBy>Saghapour, Ehsan (Campus)</cp:lastModifiedBy>
  <cp:revision>4</cp:revision>
  <dcterms:created xsi:type="dcterms:W3CDTF">2025-04-25T15:31:03Z</dcterms:created>
  <dcterms:modified xsi:type="dcterms:W3CDTF">2025-04-29T16:25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e7542bc-63e5-412b-b0a0-d9586028a7d0_Enabled">
    <vt:lpwstr>true</vt:lpwstr>
  </property>
  <property fmtid="{D5CDD505-2E9C-101B-9397-08002B2CF9AE}" pid="3" name="MSIP_Label_ae7542bc-63e5-412b-b0a0-d9586028a7d0_SetDate">
    <vt:lpwstr>2025-04-25T16:57:02Z</vt:lpwstr>
  </property>
  <property fmtid="{D5CDD505-2E9C-101B-9397-08002B2CF9AE}" pid="4" name="MSIP_Label_ae7542bc-63e5-412b-b0a0-d9586028a7d0_Method">
    <vt:lpwstr>Standard</vt:lpwstr>
  </property>
  <property fmtid="{D5CDD505-2E9C-101B-9397-08002B2CF9AE}" pid="5" name="MSIP_Label_ae7542bc-63e5-412b-b0a0-d9586028a7d0_Name">
    <vt:lpwstr>Sensitive</vt:lpwstr>
  </property>
  <property fmtid="{D5CDD505-2E9C-101B-9397-08002B2CF9AE}" pid="6" name="MSIP_Label_ae7542bc-63e5-412b-b0a0-d9586028a7d0_SiteId">
    <vt:lpwstr>d8999fe4-76af-40b3-b435-1d8977abc08c</vt:lpwstr>
  </property>
  <property fmtid="{D5CDD505-2E9C-101B-9397-08002B2CF9AE}" pid="7" name="MSIP_Label_ae7542bc-63e5-412b-b0a0-d9586028a7d0_ActionId">
    <vt:lpwstr>7248d5f7-3c30-477c-97fd-06ce1eeb5082</vt:lpwstr>
  </property>
  <property fmtid="{D5CDD505-2E9C-101B-9397-08002B2CF9AE}" pid="8" name="MSIP_Label_ae7542bc-63e5-412b-b0a0-d9586028a7d0_ContentBits">
    <vt:lpwstr>0</vt:lpwstr>
  </property>
  <property fmtid="{D5CDD505-2E9C-101B-9397-08002B2CF9AE}" pid="9" name="MSIP_Label_ae7542bc-63e5-412b-b0a0-d9586028a7d0_Tag">
    <vt:lpwstr>10, 3, 0, 1</vt:lpwstr>
  </property>
</Properties>
</file>